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38" y="4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publications\replication_hk\ewas-valid-graphda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G:\publications\replication_hk\ewas-valid-graphdat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b="1" dirty="0"/>
              <a:t>Femal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tdcurveI!$J$29</c:f>
              <c:strCache>
                <c:ptCount val="1"/>
                <c:pt idx="0">
                  <c:v>o6sa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tdcurveI!$K$33:$P$33</c:f>
                <c:numCache>
                  <c:formatCode>General</c:formatCode>
                  <c:ptCount val="6"/>
                  <c:pt idx="0">
                    <c:v>5.9639528900815662E-2</c:v>
                  </c:pt>
                  <c:pt idx="1">
                    <c:v>0.30343492209395961</c:v>
                  </c:pt>
                  <c:pt idx="2">
                    <c:v>0.69600853548847308</c:v>
                  </c:pt>
                  <c:pt idx="3">
                    <c:v>0.27898349689162721</c:v>
                  </c:pt>
                  <c:pt idx="4">
                    <c:v>0.1168270634193751</c:v>
                  </c:pt>
                  <c:pt idx="5">
                    <c:v>0.411806425210412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tdcurveI!$K$28:$P$28</c:f>
              <c:strCache>
                <c:ptCount val="6"/>
                <c:pt idx="0">
                  <c:v>Abat</c:v>
                </c:pt>
                <c:pt idx="1">
                  <c:v>Sfi1</c:v>
                </c:pt>
                <c:pt idx="2">
                  <c:v>Cerk</c:v>
                </c:pt>
                <c:pt idx="3">
                  <c:v>Gnas6</c:v>
                </c:pt>
                <c:pt idx="4">
                  <c:v>Gnas9</c:v>
                </c:pt>
                <c:pt idx="5">
                  <c:v>Oprk1</c:v>
                </c:pt>
              </c:strCache>
            </c:strRef>
          </c:cat>
          <c:val>
            <c:numRef>
              <c:f>stdcurveI!$K$29:$P$29</c:f>
              <c:numCache>
                <c:formatCode>0.000</c:formatCode>
                <c:ptCount val="6"/>
                <c:pt idx="0">
                  <c:v>0.47995717451074643</c:v>
                </c:pt>
                <c:pt idx="1">
                  <c:v>1.4740340962051965</c:v>
                </c:pt>
                <c:pt idx="2">
                  <c:v>2.2790812913625871</c:v>
                </c:pt>
                <c:pt idx="3">
                  <c:v>1.1121866602210635</c:v>
                </c:pt>
                <c:pt idx="4">
                  <c:v>0.7468575399849765</c:v>
                </c:pt>
                <c:pt idx="5">
                  <c:v>1.17656324534902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2E0-4D47-9375-081B635B60BD}"/>
            </c:ext>
          </c:extLst>
        </c:ser>
        <c:ser>
          <c:idx val="1"/>
          <c:order val="1"/>
          <c:tx>
            <c:strRef>
              <c:f>stdcurveI!$J$30</c:f>
              <c:strCache>
                <c:ptCount val="1"/>
                <c:pt idx="0">
                  <c:v>o6po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tdcurveI!$K$34:$P$34</c:f>
                <c:numCache>
                  <c:formatCode>General</c:formatCode>
                  <c:ptCount val="6"/>
                  <c:pt idx="0">
                    <c:v>0.45014240614283924</c:v>
                  </c:pt>
                  <c:pt idx="1">
                    <c:v>0.1140128717001362</c:v>
                  </c:pt>
                  <c:pt idx="2">
                    <c:v>7.1971277039508896E-2</c:v>
                  </c:pt>
                  <c:pt idx="3">
                    <c:v>7.7259996424527966E-2</c:v>
                  </c:pt>
                  <c:pt idx="4">
                    <c:v>0.56241682061061093</c:v>
                  </c:pt>
                  <c:pt idx="5">
                    <c:v>0.195394593091392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tdcurveI!$K$28:$P$28</c:f>
              <c:strCache>
                <c:ptCount val="6"/>
                <c:pt idx="0">
                  <c:v>Abat</c:v>
                </c:pt>
                <c:pt idx="1">
                  <c:v>Sfi1</c:v>
                </c:pt>
                <c:pt idx="2">
                  <c:v>Cerk</c:v>
                </c:pt>
                <c:pt idx="3">
                  <c:v>Gnas6</c:v>
                </c:pt>
                <c:pt idx="4">
                  <c:v>Gnas9</c:v>
                </c:pt>
                <c:pt idx="5">
                  <c:v>Oprk1</c:v>
                </c:pt>
              </c:strCache>
            </c:strRef>
          </c:cat>
          <c:val>
            <c:numRef>
              <c:f>stdcurveI!$K$30:$P$30</c:f>
              <c:numCache>
                <c:formatCode>0.000</c:formatCode>
                <c:ptCount val="6"/>
                <c:pt idx="0">
                  <c:v>1.1395953389378493</c:v>
                </c:pt>
                <c:pt idx="1">
                  <c:v>1.0236667203723198</c:v>
                </c:pt>
                <c:pt idx="2">
                  <c:v>1.1970448157736691</c:v>
                </c:pt>
                <c:pt idx="3">
                  <c:v>0.56840763718912946</c:v>
                </c:pt>
                <c:pt idx="4">
                  <c:v>1.4531020287249223</c:v>
                </c:pt>
                <c:pt idx="5">
                  <c:v>1.64736622816859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2E0-4D47-9375-081B635B60BD}"/>
            </c:ext>
          </c:extLst>
        </c:ser>
        <c:ser>
          <c:idx val="2"/>
          <c:order val="2"/>
          <c:tx>
            <c:strRef>
              <c:f>stdcurveI!$J$31</c:f>
              <c:strCache>
                <c:ptCount val="1"/>
                <c:pt idx="0">
                  <c:v>o3sal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tdcurveI!$K$35:$P$35</c:f>
                <c:numCache>
                  <c:formatCode>General</c:formatCode>
                  <c:ptCount val="6"/>
                  <c:pt idx="0">
                    <c:v>9.3796253774755825E-2</c:v>
                  </c:pt>
                  <c:pt idx="1">
                    <c:v>0.33638022997002104</c:v>
                  </c:pt>
                  <c:pt idx="2">
                    <c:v>0.31663374624939394</c:v>
                  </c:pt>
                  <c:pt idx="3">
                    <c:v>0.20544520948274866</c:v>
                  </c:pt>
                  <c:pt idx="4">
                    <c:v>0.14447516372667013</c:v>
                  </c:pt>
                  <c:pt idx="5">
                    <c:v>0.691117928841182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tdcurveI!$K$28:$P$28</c:f>
              <c:strCache>
                <c:ptCount val="6"/>
                <c:pt idx="0">
                  <c:v>Abat</c:v>
                </c:pt>
                <c:pt idx="1">
                  <c:v>Sfi1</c:v>
                </c:pt>
                <c:pt idx="2">
                  <c:v>Cerk</c:v>
                </c:pt>
                <c:pt idx="3">
                  <c:v>Gnas6</c:v>
                </c:pt>
                <c:pt idx="4">
                  <c:v>Gnas9</c:v>
                </c:pt>
                <c:pt idx="5">
                  <c:v>Oprk1</c:v>
                </c:pt>
              </c:strCache>
            </c:strRef>
          </c:cat>
          <c:val>
            <c:numRef>
              <c:f>stdcurveI!$K$31:$P$31</c:f>
              <c:numCache>
                <c:formatCode>0.000</c:formatCode>
                <c:ptCount val="6"/>
                <c:pt idx="0">
                  <c:v>0.74321353113642952</c:v>
                </c:pt>
                <c:pt idx="1">
                  <c:v>1.8678420339611155</c:v>
                </c:pt>
                <c:pt idx="2">
                  <c:v>2.7109420691154611</c:v>
                </c:pt>
                <c:pt idx="3">
                  <c:v>1.1693147701475641</c:v>
                </c:pt>
                <c:pt idx="4">
                  <c:v>0.8501222459754002</c:v>
                </c:pt>
                <c:pt idx="5">
                  <c:v>1.25782894521504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2E0-4D47-9375-081B635B60BD}"/>
            </c:ext>
          </c:extLst>
        </c:ser>
        <c:ser>
          <c:idx val="3"/>
          <c:order val="3"/>
          <c:tx>
            <c:strRef>
              <c:f>stdcurveI!$J$32</c:f>
              <c:strCache>
                <c:ptCount val="1"/>
                <c:pt idx="0">
                  <c:v>o3P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tdcurveI!$K$36:$P$36</c:f>
                <c:numCache>
                  <c:formatCode>General</c:formatCode>
                  <c:ptCount val="6"/>
                  <c:pt idx="0">
                    <c:v>0.18119175668345433</c:v>
                  </c:pt>
                  <c:pt idx="1">
                    <c:v>0.23026473707598535</c:v>
                  </c:pt>
                  <c:pt idx="2">
                    <c:v>0.28683888768829002</c:v>
                  </c:pt>
                  <c:pt idx="3">
                    <c:v>0.70563486389715968</c:v>
                  </c:pt>
                  <c:pt idx="4">
                    <c:v>0.19828468597492124</c:v>
                  </c:pt>
                  <c:pt idx="5">
                    <c:v>0.1374707853437419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tdcurveI!$K$28:$P$28</c:f>
              <c:strCache>
                <c:ptCount val="6"/>
                <c:pt idx="0">
                  <c:v>Abat</c:v>
                </c:pt>
                <c:pt idx="1">
                  <c:v>Sfi1</c:v>
                </c:pt>
                <c:pt idx="2">
                  <c:v>Cerk</c:v>
                </c:pt>
                <c:pt idx="3">
                  <c:v>Gnas6</c:v>
                </c:pt>
                <c:pt idx="4">
                  <c:v>Gnas9</c:v>
                </c:pt>
                <c:pt idx="5">
                  <c:v>Oprk1</c:v>
                </c:pt>
              </c:strCache>
            </c:strRef>
          </c:cat>
          <c:val>
            <c:numRef>
              <c:f>stdcurveI!$K$32:$P$32</c:f>
              <c:numCache>
                <c:formatCode>0.000</c:formatCode>
                <c:ptCount val="6"/>
                <c:pt idx="0">
                  <c:v>1.1449814359794224</c:v>
                </c:pt>
                <c:pt idx="1">
                  <c:v>1.3839778498792625</c:v>
                </c:pt>
                <c:pt idx="2">
                  <c:v>1.549354008393097</c:v>
                </c:pt>
                <c:pt idx="3">
                  <c:v>1.3566404313834728</c:v>
                </c:pt>
                <c:pt idx="4">
                  <c:v>1.0322343372636142</c:v>
                </c:pt>
                <c:pt idx="5">
                  <c:v>0.777228254528200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2E0-4D47-9375-081B635B60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02042728"/>
        <c:axId val="302041416"/>
      </c:barChart>
      <c:catAx>
        <c:axId val="3020427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2041416"/>
        <c:crosses val="autoZero"/>
        <c:auto val="1"/>
        <c:lblAlgn val="ctr"/>
        <c:lblOffset val="100"/>
        <c:noMultiLvlLbl val="0"/>
      </c:catAx>
      <c:valAx>
        <c:axId val="302041416"/>
        <c:scaling>
          <c:orientation val="minMax"/>
        </c:scaling>
        <c:delete val="0"/>
        <c:axPos val="l"/>
        <c:numFmt formatCode="0.0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20427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b="1"/>
              <a:t>Mal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tdcurveI!$J$37</c:f>
              <c:strCache>
                <c:ptCount val="1"/>
                <c:pt idx="0">
                  <c:v>o6sa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tdcurveI!$K$41:$P$41</c:f>
                <c:numCache>
                  <c:formatCode>General</c:formatCode>
                  <c:ptCount val="6"/>
                  <c:pt idx="0">
                    <c:v>8.2901619140821767E-2</c:v>
                  </c:pt>
                  <c:pt idx="1">
                    <c:v>0.76432651606389534</c:v>
                  </c:pt>
                  <c:pt idx="2">
                    <c:v>0.93678389472162082</c:v>
                  </c:pt>
                  <c:pt idx="3">
                    <c:v>0.45010863324797629</c:v>
                  </c:pt>
                  <c:pt idx="4">
                    <c:v>0.12659202179646956</c:v>
                  </c:pt>
                  <c:pt idx="5">
                    <c:v>0.171065653968273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tdcurveI!$K$28:$P$28</c:f>
              <c:strCache>
                <c:ptCount val="6"/>
                <c:pt idx="0">
                  <c:v>Abat</c:v>
                </c:pt>
                <c:pt idx="1">
                  <c:v>Sfi1</c:v>
                </c:pt>
                <c:pt idx="2">
                  <c:v>Cerk</c:v>
                </c:pt>
                <c:pt idx="3">
                  <c:v>Gnas6</c:v>
                </c:pt>
                <c:pt idx="4">
                  <c:v>Gnas9</c:v>
                </c:pt>
                <c:pt idx="5">
                  <c:v>Oprk1</c:v>
                </c:pt>
              </c:strCache>
            </c:strRef>
          </c:cat>
          <c:val>
            <c:numRef>
              <c:f>stdcurveI!$K$37:$P$37</c:f>
              <c:numCache>
                <c:formatCode>0.000</c:formatCode>
                <c:ptCount val="6"/>
                <c:pt idx="0">
                  <c:v>0.55070275002735958</c:v>
                </c:pt>
                <c:pt idx="1">
                  <c:v>1.3091427856729672</c:v>
                </c:pt>
                <c:pt idx="2">
                  <c:v>1.7415896690274064</c:v>
                </c:pt>
                <c:pt idx="3">
                  <c:v>0.83485780842049317</c:v>
                </c:pt>
                <c:pt idx="4">
                  <c:v>0.48588246329909479</c:v>
                </c:pt>
                <c:pt idx="5">
                  <c:v>0.556878195206603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14-4215-8037-733CF6DBC1F5}"/>
            </c:ext>
          </c:extLst>
        </c:ser>
        <c:ser>
          <c:idx val="1"/>
          <c:order val="1"/>
          <c:tx>
            <c:strRef>
              <c:f>stdcurveI!$J$38</c:f>
              <c:strCache>
                <c:ptCount val="1"/>
                <c:pt idx="0">
                  <c:v>o6po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tdcurveI!$K$42:$P$42</c:f>
                <c:numCache>
                  <c:formatCode>General</c:formatCode>
                  <c:ptCount val="6"/>
                  <c:pt idx="0">
                    <c:v>0.2515950992804088</c:v>
                  </c:pt>
                  <c:pt idx="1">
                    <c:v>0.40041565209179697</c:v>
                  </c:pt>
                  <c:pt idx="2">
                    <c:v>0.89939836420391761</c:v>
                  </c:pt>
                  <c:pt idx="3">
                    <c:v>0.57867721664852001</c:v>
                  </c:pt>
                  <c:pt idx="4">
                    <c:v>0.16542595648676001</c:v>
                  </c:pt>
                  <c:pt idx="5">
                    <c:v>0.4125752564450841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tdcurveI!$K$28:$P$28</c:f>
              <c:strCache>
                <c:ptCount val="6"/>
                <c:pt idx="0">
                  <c:v>Abat</c:v>
                </c:pt>
                <c:pt idx="1">
                  <c:v>Sfi1</c:v>
                </c:pt>
                <c:pt idx="2">
                  <c:v>Cerk</c:v>
                </c:pt>
                <c:pt idx="3">
                  <c:v>Gnas6</c:v>
                </c:pt>
                <c:pt idx="4">
                  <c:v>Gnas9</c:v>
                </c:pt>
                <c:pt idx="5">
                  <c:v>Oprk1</c:v>
                </c:pt>
              </c:strCache>
            </c:strRef>
          </c:cat>
          <c:val>
            <c:numRef>
              <c:f>stdcurveI!$K$38:$P$38</c:f>
              <c:numCache>
                <c:formatCode>0.000</c:formatCode>
                <c:ptCount val="6"/>
                <c:pt idx="0">
                  <c:v>0.9268032431900145</c:v>
                </c:pt>
                <c:pt idx="1">
                  <c:v>1.8921089214314748</c:v>
                </c:pt>
                <c:pt idx="2">
                  <c:v>2.4494206728667782</c:v>
                </c:pt>
                <c:pt idx="3">
                  <c:v>1.228943299672294</c:v>
                </c:pt>
                <c:pt idx="4">
                  <c:v>1.0800933471814396</c:v>
                </c:pt>
                <c:pt idx="5">
                  <c:v>1.12477798469550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714-4215-8037-733CF6DBC1F5}"/>
            </c:ext>
          </c:extLst>
        </c:ser>
        <c:ser>
          <c:idx val="2"/>
          <c:order val="2"/>
          <c:tx>
            <c:strRef>
              <c:f>stdcurveI!$J$39</c:f>
              <c:strCache>
                <c:ptCount val="1"/>
                <c:pt idx="0">
                  <c:v>o3sal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tdcurveI!$K$43:$P$43</c:f>
                <c:numCache>
                  <c:formatCode>General</c:formatCode>
                  <c:ptCount val="6"/>
                  <c:pt idx="0">
                    <c:v>2.3886079784630587E-2</c:v>
                  </c:pt>
                  <c:pt idx="1">
                    <c:v>0.5123067073024572</c:v>
                  </c:pt>
                  <c:pt idx="2">
                    <c:v>0.52582260819654369</c:v>
                  </c:pt>
                  <c:pt idx="3">
                    <c:v>0.35704360286117082</c:v>
                  </c:pt>
                  <c:pt idx="4">
                    <c:v>9.3162605283426E-2</c:v>
                  </c:pt>
                  <c:pt idx="5">
                    <c:v>0.379942856021423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tdcurveI!$K$28:$P$28</c:f>
              <c:strCache>
                <c:ptCount val="6"/>
                <c:pt idx="0">
                  <c:v>Abat</c:v>
                </c:pt>
                <c:pt idx="1">
                  <c:v>Sfi1</c:v>
                </c:pt>
                <c:pt idx="2">
                  <c:v>Cerk</c:v>
                </c:pt>
                <c:pt idx="3">
                  <c:v>Gnas6</c:v>
                </c:pt>
                <c:pt idx="4">
                  <c:v>Gnas9</c:v>
                </c:pt>
                <c:pt idx="5">
                  <c:v>Oprk1</c:v>
                </c:pt>
              </c:strCache>
            </c:strRef>
          </c:cat>
          <c:val>
            <c:numRef>
              <c:f>stdcurveI!$K$39:$P$39</c:f>
              <c:numCache>
                <c:formatCode>0.000</c:formatCode>
                <c:ptCount val="6"/>
                <c:pt idx="0">
                  <c:v>0.74420055378473238</c:v>
                </c:pt>
                <c:pt idx="1">
                  <c:v>1.4757209397168829</c:v>
                </c:pt>
                <c:pt idx="2">
                  <c:v>1.8982246155167048</c:v>
                </c:pt>
                <c:pt idx="3">
                  <c:v>1.0766229863592949</c:v>
                </c:pt>
                <c:pt idx="4">
                  <c:v>0.80637523208517126</c:v>
                </c:pt>
                <c:pt idx="5">
                  <c:v>0.824858870751365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714-4215-8037-733CF6DBC1F5}"/>
            </c:ext>
          </c:extLst>
        </c:ser>
        <c:ser>
          <c:idx val="3"/>
          <c:order val="3"/>
          <c:tx>
            <c:strRef>
              <c:f>stdcurveI!$J$40</c:f>
              <c:strCache>
                <c:ptCount val="1"/>
                <c:pt idx="0">
                  <c:v>o3P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tdcurveI!$K$44:$P$44</c:f>
                <c:numCache>
                  <c:formatCode>General</c:formatCode>
                  <c:ptCount val="6"/>
                  <c:pt idx="0">
                    <c:v>6.6381771792216215E-2</c:v>
                  </c:pt>
                  <c:pt idx="1">
                    <c:v>0.15969035132339685</c:v>
                  </c:pt>
                  <c:pt idx="2">
                    <c:v>9.0714902894613175E-3</c:v>
                  </c:pt>
                  <c:pt idx="3">
                    <c:v>6.5204921244486971E-2</c:v>
                  </c:pt>
                  <c:pt idx="4">
                    <c:v>0.2265408926510516</c:v>
                  </c:pt>
                  <c:pt idx="5">
                    <c:v>0.2946749972247634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tdcurveI!$K$28:$P$28</c:f>
              <c:strCache>
                <c:ptCount val="6"/>
                <c:pt idx="0">
                  <c:v>Abat</c:v>
                </c:pt>
                <c:pt idx="1">
                  <c:v>Sfi1</c:v>
                </c:pt>
                <c:pt idx="2">
                  <c:v>Cerk</c:v>
                </c:pt>
                <c:pt idx="3">
                  <c:v>Gnas6</c:v>
                </c:pt>
                <c:pt idx="4">
                  <c:v>Gnas9</c:v>
                </c:pt>
                <c:pt idx="5">
                  <c:v>Oprk1</c:v>
                </c:pt>
              </c:strCache>
            </c:strRef>
          </c:cat>
          <c:val>
            <c:numRef>
              <c:f>stdcurveI!$K$40:$P$40</c:f>
              <c:numCache>
                <c:formatCode>0.000</c:formatCode>
                <c:ptCount val="6"/>
                <c:pt idx="0">
                  <c:v>0.89436449672594753</c:v>
                </c:pt>
                <c:pt idx="1">
                  <c:v>1.0516610795547428</c:v>
                </c:pt>
                <c:pt idx="2">
                  <c:v>1.6385240834978845</c:v>
                </c:pt>
                <c:pt idx="3">
                  <c:v>0.70254574379128032</c:v>
                </c:pt>
                <c:pt idx="4">
                  <c:v>1.132276023494267</c:v>
                </c:pt>
                <c:pt idx="5">
                  <c:v>1.30723150145902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714-4215-8037-733CF6DBC1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03768280"/>
        <c:axId val="303768936"/>
      </c:barChart>
      <c:catAx>
        <c:axId val="303768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3768936"/>
        <c:crosses val="autoZero"/>
        <c:auto val="1"/>
        <c:lblAlgn val="ctr"/>
        <c:lblOffset val="100"/>
        <c:noMultiLvlLbl val="0"/>
      </c:catAx>
      <c:valAx>
        <c:axId val="303768936"/>
        <c:scaling>
          <c:orientation val="minMax"/>
        </c:scaling>
        <c:delete val="0"/>
        <c:axPos val="l"/>
        <c:numFmt formatCode="0.0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37682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0F4989-840A-4BD0-AD6E-ADE63CE0F38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06F2AAD-0DFA-4F81-9120-220C6510C5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55E37E-7604-4447-8D5F-6C4280A069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8C9A6-22D7-43C9-99BA-10946D5534E1}" type="datetimeFigureOut">
              <a:rPr lang="en-GB" smtClean="0"/>
              <a:t>21/09/2017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225B78-471F-4E9A-A651-9C10A2051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2F833C-6EBB-42EB-B1C3-9878A472EA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7C922-59A9-416E-A14D-6CBF0EA836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88128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5ECEEC-9B19-45D2-9953-C6894ABD61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D89496C-EE5C-4590-9181-5571488B94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D80884-1302-4048-9A8A-50561DA9B3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8C9A6-22D7-43C9-99BA-10946D5534E1}" type="datetimeFigureOut">
              <a:rPr lang="en-GB" smtClean="0"/>
              <a:t>21/09/2017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895F3D-A685-4792-B773-5469ABAA10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DA7F57-4328-43E7-963A-A5E74657E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7C922-59A9-416E-A14D-6CBF0EA836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80948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6616944-198F-4132-BC4A-8C828FF7447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51B816-E450-468C-9A89-6359486ECB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411D97-CC11-4612-BDC2-33806A2AFB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8C9A6-22D7-43C9-99BA-10946D5534E1}" type="datetimeFigureOut">
              <a:rPr lang="en-GB" smtClean="0"/>
              <a:t>21/09/2017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2E449D-4398-4573-979D-A7A06B4CC3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3735FD-E52C-4022-9929-66903BC861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7C922-59A9-416E-A14D-6CBF0EA836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8731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300352-C2F3-45D9-9E54-99B2855EAB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4B12CC-2773-4ED0-ACA8-CF6F8A6393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92DC82-FF2A-46C7-9F12-03EF8EE0A2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8C9A6-22D7-43C9-99BA-10946D5534E1}" type="datetimeFigureOut">
              <a:rPr lang="en-GB" smtClean="0"/>
              <a:t>21/09/2017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BD973C-4514-40F0-813F-DDEFD04C9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D5A25F-0E63-4F10-998F-09F00BC647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7C922-59A9-416E-A14D-6CBF0EA836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39497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4AD9C7-A281-44BA-B7EE-F3217BAFC2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F0CCE2-20A9-433A-B859-D2E47A401A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90971C-DEB8-40C7-98D0-915661619E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8C9A6-22D7-43C9-99BA-10946D5534E1}" type="datetimeFigureOut">
              <a:rPr lang="en-GB" smtClean="0"/>
              <a:t>21/09/2017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966993-CEDE-4487-9D68-ABF459F6DF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76D7F5-6624-4EDC-9653-D326321D92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7C922-59A9-416E-A14D-6CBF0EA836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60628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0E1866-CD94-4715-A7C7-E4429A7781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27B9E7-B6A7-4219-A528-015BCBF2A4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D80AF81-6D9B-493B-B6A6-EE675D986D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10B96F-5D20-4C36-B8D6-345275506F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8C9A6-22D7-43C9-99BA-10946D5534E1}" type="datetimeFigureOut">
              <a:rPr lang="en-GB" smtClean="0"/>
              <a:t>21/09/2017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720B6E-265A-4C18-8FC1-2E127EE627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6F030E-FFB8-4454-B6A5-452C2B8C45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7C922-59A9-416E-A14D-6CBF0EA836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73150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AD42AE-A46D-4120-9E02-4F0AD10054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329A7CA-824D-4E85-85C5-E65AC2DF65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A86D6A-5063-48CD-944B-E30A4811D5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87B2F97-4B20-446F-9536-C23406EF6FE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A126EDE-1A49-473D-9082-A4AC9819769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FA1F725-9E36-40D2-BEA2-D4DC0760F4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8C9A6-22D7-43C9-99BA-10946D5534E1}" type="datetimeFigureOut">
              <a:rPr lang="en-GB" smtClean="0"/>
              <a:t>21/09/2017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AB83314-BD4E-4475-80FD-8888ACEEA6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B869471-BB0B-4FBC-A3BA-D272752FFB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7C922-59A9-416E-A14D-6CBF0EA836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25875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70906A-AC6D-4CC7-8BE6-1259D89565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5DE86AD-BC31-484E-AB91-3B7C77447C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8C9A6-22D7-43C9-99BA-10946D5534E1}" type="datetimeFigureOut">
              <a:rPr lang="en-GB" smtClean="0"/>
              <a:t>21/09/2017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38144DA-F284-4E6C-A7BC-4D2A24F8ED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71F4366-E266-4317-A4C0-355DDF7C52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7C922-59A9-416E-A14D-6CBF0EA836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7706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9DE786A-FC33-42CE-A10E-44B5A3BE6A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8C9A6-22D7-43C9-99BA-10946D5534E1}" type="datetimeFigureOut">
              <a:rPr lang="en-GB" smtClean="0"/>
              <a:t>21/09/2017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975D64E-3ECB-4488-96D4-7970FAAAAF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AEFBE32-EA60-46FB-98F9-2737EE6795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7C922-59A9-416E-A14D-6CBF0EA836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3280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0F1CD0-9004-4ABA-8188-60AD12BBEC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A915B4-3DC1-4035-8F31-A029D4CB69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6CBE181-4033-499D-B622-0122B03A2D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86296D-BD85-432C-BE81-82D41872BF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8C9A6-22D7-43C9-99BA-10946D5534E1}" type="datetimeFigureOut">
              <a:rPr lang="en-GB" smtClean="0"/>
              <a:t>21/09/2017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D4D159-97F8-491A-A535-2737B080A6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E8F94F-B623-41C6-911D-64A0656EE2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7C922-59A9-416E-A14D-6CBF0EA836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22516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647F22-8FEE-4907-B6CA-171B91762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D808220-16F2-491B-88E3-16E719A654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CEAEF9F-1B15-4294-BC6B-3C0DF95696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30A6648-31C3-44F3-8729-30F64452E5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8C9A6-22D7-43C9-99BA-10946D5534E1}" type="datetimeFigureOut">
              <a:rPr lang="en-GB" smtClean="0"/>
              <a:t>21/09/2017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E82D40-3E08-4CFA-82D9-E8ECE387BD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50320F-225A-4D6C-916F-C0212B18BA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E7C922-59A9-416E-A14D-6CBF0EA836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3973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5201121-F351-4234-95D7-3CDD01F112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30F23A-FA67-4C8A-944E-D9099382E5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0037CE-639E-407B-B398-07BF445CA2D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D8C9A6-22D7-43C9-99BA-10946D5534E1}" type="datetimeFigureOut">
              <a:rPr lang="en-GB" smtClean="0"/>
              <a:t>21/09/2017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82EE97-A23F-4383-B425-2DFC8BBA01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D1CDEE-1A07-438E-AC1F-77239728D45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E7C922-59A9-416E-A14D-6CBF0EA836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46349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3428AA31-7E75-4CCE-9844-BB77968E7F9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5428142"/>
              </p:ext>
            </p:extLst>
          </p:nvPr>
        </p:nvGraphicFramePr>
        <p:xfrm>
          <a:off x="1343142" y="2057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F57E5039-D65C-44AA-BFEF-B5141F9958B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6925684"/>
              </p:ext>
            </p:extLst>
          </p:nvPr>
        </p:nvGraphicFramePr>
        <p:xfrm>
          <a:off x="6338514" y="2057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87EBDC4A-8705-4D8F-8EC5-39F5FD789528}"/>
              </a:ext>
            </a:extLst>
          </p:cNvPr>
          <p:cNvSpPr txBox="1"/>
          <p:nvPr/>
        </p:nvSpPr>
        <p:spPr>
          <a:xfrm>
            <a:off x="1494845" y="1820849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0300623-52E9-4000-961C-315ED98D95DC}"/>
              </a:ext>
            </a:extLst>
          </p:cNvPr>
          <p:cNvSpPr txBox="1"/>
          <p:nvPr/>
        </p:nvSpPr>
        <p:spPr>
          <a:xfrm>
            <a:off x="6410076" y="1820849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7708688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zil</dc:creator>
  <cp:lastModifiedBy>bazil</cp:lastModifiedBy>
  <cp:revision>3</cp:revision>
  <dcterms:created xsi:type="dcterms:W3CDTF">2017-09-22T04:30:47Z</dcterms:created>
  <dcterms:modified xsi:type="dcterms:W3CDTF">2017-09-22T04:35:35Z</dcterms:modified>
</cp:coreProperties>
</file>